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A6642-F98C-4C85-B633-15E0392CB6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FBA23-8E71-4E15-A00E-FE68514672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1EB9D-9C70-4B27-BC5B-8AA413C6A5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0F2445-1D17-4518-AB3C-5EDE7856E0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8C8F5-E10A-4494-BF8A-93D20E9BA0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D63C2-B665-436A-8F64-65E7E1F187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845A1-3216-4821-98A5-70E5D13822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E1D92-6AD9-4464-A619-BBEBAC6F1D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B0DF5-76A1-4F41-A402-DFB264BBD9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CEAF5-1326-4C43-8A00-3D9630F84C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EF49A-3117-48E2-81F0-D6F5B36101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74A5B-4D59-4CD4-82F8-25E9EEA12C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040D814-EB5E-4014-9175-07F2C7B01F5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390840" y="2311560"/>
            <a:ext cx="2476440" cy="2108160"/>
            <a:chOff x="3390840" y="2311560"/>
            <a:chExt cx="2476440" cy="2108160"/>
          </a:xfrm>
        </p:grpSpPr>
        <p:sp>
          <p:nvSpPr>
            <p:cNvPr id="42" name=""/>
            <p:cNvSpPr/>
            <p:nvPr/>
          </p:nvSpPr>
          <p:spPr>
            <a:xfrm>
              <a:off x="4362480" y="2311560"/>
              <a:ext cx="51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BK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4535280" y="2543040"/>
              <a:ext cx="247680" cy="1454400"/>
              <a:chOff x="4535280" y="2543040"/>
              <a:chExt cx="247680" cy="1454400"/>
            </a:xfrm>
          </p:grpSpPr>
          <p:sp>
            <p:nvSpPr>
              <p:cNvPr id="44" name=""/>
              <p:cNvSpPr/>
              <p:nvPr/>
            </p:nvSpPr>
            <p:spPr>
              <a:xfrm>
                <a:off x="4535280" y="2543040"/>
                <a:ext cx="2476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N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4547880" y="276084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S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4551120" y="3403800"/>
                <a:ext cx="205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J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4552200" y="2930400"/>
                <a:ext cx="211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4570560" y="2573280"/>
                <a:ext cx="36360" cy="1098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4572000" y="2828880"/>
                <a:ext cx="36720" cy="637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6920" bIns="169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572000" y="2914560"/>
                <a:ext cx="36720" cy="2192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572000" y="3156120"/>
                <a:ext cx="36720" cy="8413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572000" y="2710080"/>
                <a:ext cx="36720" cy="918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542120" y="265608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T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"/>
            <p:cNvSpPr/>
            <p:nvPr/>
          </p:nvSpPr>
          <p:spPr>
            <a:xfrm>
              <a:off x="5276880" y="2311560"/>
              <a:ext cx="590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BK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551560" y="2570040"/>
              <a:ext cx="36360" cy="1143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530320" y="2511360"/>
              <a:ext cx="237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526360" y="3083040"/>
              <a:ext cx="237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526000" y="2814480"/>
              <a:ext cx="303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551560" y="3735360"/>
              <a:ext cx="36360" cy="633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560" bIns="16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528160" y="3963960"/>
              <a:ext cx="24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Q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529600" y="3675240"/>
              <a:ext cx="2340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V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538240" y="3849840"/>
              <a:ext cx="2750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L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536080" y="3765600"/>
              <a:ext cx="235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Verdana"/>
                </a:rPr>
                <a:t>K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551560" y="3828960"/>
              <a:ext cx="36360" cy="637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6920" bIns="16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551560" y="3916440"/>
              <a:ext cx="36360" cy="363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551560" y="3978360"/>
              <a:ext cx="36360" cy="1728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390840" y="2311560"/>
              <a:ext cx="495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BK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" name=""/>
            <p:cNvGrpSpPr/>
            <p:nvPr/>
          </p:nvGrpSpPr>
          <p:grpSpPr>
            <a:xfrm>
              <a:off x="3527280" y="2570040"/>
              <a:ext cx="361800" cy="1298880"/>
              <a:chOff x="3527280" y="2570040"/>
              <a:chExt cx="361800" cy="1298880"/>
            </a:xfrm>
          </p:grpSpPr>
          <p:sp>
            <p:nvSpPr>
              <p:cNvPr id="69" name=""/>
              <p:cNvSpPr/>
              <p:nvPr/>
            </p:nvSpPr>
            <p:spPr>
              <a:xfrm>
                <a:off x="3571920" y="2570040"/>
                <a:ext cx="36360" cy="7682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3571920" y="3365280"/>
                <a:ext cx="36360" cy="1825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571920" y="3571560"/>
                <a:ext cx="36360" cy="1461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3571920" y="3743280"/>
                <a:ext cx="36360" cy="554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8640" bIns="86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551760" y="2809800"/>
                <a:ext cx="235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544200" y="3375000"/>
                <a:ext cx="263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W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3559320" y="355104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E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3562200" y="3668400"/>
                <a:ext cx="326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P,O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3527280" y="3597120"/>
                <a:ext cx="0" cy="136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3527280" y="2633400"/>
                <a:ext cx="0" cy="6397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"/>
            <p:cNvSpPr/>
            <p:nvPr/>
          </p:nvSpPr>
          <p:spPr>
            <a:xfrm>
              <a:off x="3905280" y="2311560"/>
              <a:ext cx="533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BK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0" name=""/>
            <p:cNvGrpSpPr/>
            <p:nvPr/>
          </p:nvGrpSpPr>
          <p:grpSpPr>
            <a:xfrm>
              <a:off x="4050360" y="2576520"/>
              <a:ext cx="271080" cy="1210320"/>
              <a:chOff x="4050360" y="2576520"/>
              <a:chExt cx="271080" cy="1210320"/>
            </a:xfrm>
          </p:grpSpPr>
          <p:sp>
            <p:nvSpPr>
              <p:cNvPr id="81" name=""/>
              <p:cNvSpPr/>
              <p:nvPr/>
            </p:nvSpPr>
            <p:spPr>
              <a:xfrm>
                <a:off x="4079520" y="2576520"/>
                <a:ext cx="36360" cy="4939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079520" y="3173400"/>
                <a:ext cx="36360" cy="2746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079520" y="3583080"/>
                <a:ext cx="36360" cy="460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720" bIns="-7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079520" y="3095640"/>
                <a:ext cx="36360" cy="558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9000" bIns="9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4079520" y="3468960"/>
                <a:ext cx="36360" cy="918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079520" y="3652920"/>
                <a:ext cx="36360" cy="633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6560" bIns="165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064040" y="2764080"/>
                <a:ext cx="235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R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4071240" y="3183120"/>
                <a:ext cx="205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J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4067280" y="3413160"/>
                <a:ext cx="211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I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050360" y="3506760"/>
                <a:ext cx="2494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O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4058280" y="3024360"/>
                <a:ext cx="2631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W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060800" y="3586320"/>
                <a:ext cx="2340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P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" name=""/>
            <p:cNvSpPr/>
            <p:nvPr/>
          </p:nvSpPr>
          <p:spPr>
            <a:xfrm>
              <a:off x="4800600" y="2311560"/>
              <a:ext cx="611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  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BK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4" name=""/>
            <p:cNvGrpSpPr/>
            <p:nvPr/>
          </p:nvGrpSpPr>
          <p:grpSpPr>
            <a:xfrm>
              <a:off x="5029200" y="2571840"/>
              <a:ext cx="262440" cy="1847880"/>
              <a:chOff x="5029200" y="2571840"/>
              <a:chExt cx="262440" cy="1847880"/>
            </a:xfrm>
          </p:grpSpPr>
          <p:sp>
            <p:nvSpPr>
              <p:cNvPr id="95" name=""/>
              <p:cNvSpPr/>
              <p:nvPr/>
            </p:nvSpPr>
            <p:spPr>
              <a:xfrm>
                <a:off x="5089680" y="2573280"/>
                <a:ext cx="36360" cy="6667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086440" y="3378240"/>
                <a:ext cx="36360" cy="10414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5072040" y="2571840"/>
                <a:ext cx="20520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J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5061960" y="3735360"/>
                <a:ext cx="2264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F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5032440" y="2589120"/>
                <a:ext cx="0" cy="5936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  <a:head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 flipV="1">
                <a:off x="5029200" y="3401640"/>
                <a:ext cx="0" cy="10047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  <a:tailEnd len="sm" type="triangle" w="sm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5087880" y="3273480"/>
                <a:ext cx="36720" cy="730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5054400" y="3211560"/>
                <a:ext cx="23724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Verdana"/>
                  </a:rPr>
                  <a:t>C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3" name=""/>
          <p:cNvSpPr/>
          <p:nvPr/>
        </p:nvSpPr>
        <p:spPr>
          <a:xfrm>
            <a:off x="1981080" y="1382760"/>
            <a:ext cx="512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5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utative ancestral Brassica karyotype (ABK2-ABK6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13T07:43:02Z</dcterms:created>
  <dc:creator>PRIYA</dc:creator>
  <dc:description/>
  <dc:language>en-US</dc:language>
  <cp:lastModifiedBy>PRIYA</cp:lastModifiedBy>
  <dcterms:modified xsi:type="dcterms:W3CDTF">2008-02-01T10:40:42Z</dcterms:modified>
  <cp:revision>17</cp:revision>
  <dc:subject/>
  <dc:title>Slide 1</dc:title>
</cp:coreProperties>
</file>